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323"/>
    <p:restoredTop sz="96327"/>
  </p:normalViewPr>
  <p:slideViewPr>
    <p:cSldViewPr snapToGrid="0">
      <p:cViewPr>
        <p:scale>
          <a:sx n="116" d="100"/>
          <a:sy n="116" d="100"/>
        </p:scale>
        <p:origin x="368" y="3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B08AB-AAA4-189C-B9F3-314D446C76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82A348-91A9-DBF8-05CE-3A235D29B5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A64215-990E-7FEC-1D89-E0795827BA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6E56B-0234-D14D-B041-EE174572E5FB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9CC870-625D-479A-8939-D37749C39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9D3834-B50B-6682-5D09-4B4EA30DF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BC2FA-A6A1-4945-AEBF-D322C22E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503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53AA9A-A6C8-80A5-B984-C016530AB7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084F16-6C5B-74DD-5E4B-58DFA79616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AB03E4-CBE8-906C-5733-21BF2F6D7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6E56B-0234-D14D-B041-EE174572E5FB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4A02E3-8C7C-F00C-F494-232CF1920F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CCF660-83D4-CB74-0021-9DFF220A8D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BC2FA-A6A1-4945-AEBF-D322C22E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232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E673D23-C7B8-F5E8-85C9-6378C90773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83C6EA-EB08-5B92-7E2B-3B37773FD1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0A847-DB42-2C18-49B3-C121DB563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6E56B-0234-D14D-B041-EE174572E5FB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A5E5D4-F00B-EA04-3FCF-2FE4BBF4B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3F628C-EDEE-5F37-0DAB-627209E1A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BC2FA-A6A1-4945-AEBF-D322C22E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282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8F409C-4068-380C-8D60-01DEA65FE0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073BAD-D072-6437-C502-6966D90A39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682CEA-0A47-1FDA-70DB-60287E02A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6E56B-0234-D14D-B041-EE174572E5FB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7F7B05-1351-1A90-E712-DEFEDC9D0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29D07-39EF-C671-DFAC-3C3E972CE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BC2FA-A6A1-4945-AEBF-D322C22E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591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B9C47-4F97-6360-CE0F-226C3774A0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46BFCC-7DE7-B35B-1AFE-5249352C8A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BB051E-CBF6-1485-1995-830D195F7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6E56B-0234-D14D-B041-EE174572E5FB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FA164F-FAEE-16C2-F24D-ED2E8D18A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D0F487-32B0-BA54-2DA6-9F8EAE9E5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BC2FA-A6A1-4945-AEBF-D322C22E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163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9E833C-96B1-383C-AC4F-27636F9C3D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90D558-2813-3DD1-9925-52BAF1F266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DB8D0C-56DB-5F79-EEEA-C32395B976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F8119D-59DD-147A-BEBA-596DD272A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6E56B-0234-D14D-B041-EE174572E5FB}" type="datetimeFigureOut">
              <a:rPr lang="en-US" smtClean="0"/>
              <a:t>5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DEC755-9424-7DA2-6C92-FB6AEF238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55B394-56F3-7509-43B8-03062981E6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BC2FA-A6A1-4945-AEBF-D322C22E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903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A7F6BC-59B0-74CE-6452-DF0697596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31826F-2D4F-3AD9-E353-70ED01009F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313943-25DC-B449-DD2F-A8BCFA2822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93C4FF7-D084-CD45-7819-9A763FE179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1839013-3EAA-34E8-0CFB-B1AECF7FE6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233DAB6-250E-E4E1-CFDD-79EFC6B26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6E56B-0234-D14D-B041-EE174572E5FB}" type="datetimeFigureOut">
              <a:rPr lang="en-US" smtClean="0"/>
              <a:t>5/16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7D33B18-C507-84D3-5E4A-C1EF723EE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C069839-0FF4-4146-6EB7-8927B370B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BC2FA-A6A1-4945-AEBF-D322C22E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115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A8DC63-796D-4541-530B-21074501B3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103DC47-B127-5D50-B22B-FAB499E68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6E56B-0234-D14D-B041-EE174572E5FB}" type="datetimeFigureOut">
              <a:rPr lang="en-US" smtClean="0"/>
              <a:t>5/16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536DD10-1A50-C0E0-4720-38B481755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66490B-68AE-682A-F250-490A8C111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BC2FA-A6A1-4945-AEBF-D322C22E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649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4B1BAB-E570-3DD0-9591-685398EE4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6E56B-0234-D14D-B041-EE174572E5FB}" type="datetimeFigureOut">
              <a:rPr lang="en-US" smtClean="0"/>
              <a:t>5/16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1CC245-F9CB-AA0B-C401-44C49F80A9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51DBEA-D5AD-F83A-2AB3-8C3CB92CBF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BC2FA-A6A1-4945-AEBF-D322C22E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794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98CEF8-CFC0-3A6D-5BCF-E5EC737726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AC95F5-9FD9-EC9D-EE14-4D37DD2496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732406-4212-7C91-A2F5-51491C771B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27E361-9371-76B9-6AC8-63C4A28A7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6E56B-0234-D14D-B041-EE174572E5FB}" type="datetimeFigureOut">
              <a:rPr lang="en-US" smtClean="0"/>
              <a:t>5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4ECEC0-C4C6-FD8E-0C19-50FBD0B42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933F60-C27A-B064-CB63-895AE8D61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BC2FA-A6A1-4945-AEBF-D322C22E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536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6B7DE2-4EAA-EC94-DD57-AE8C621E45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DB7180A-25BB-5507-4A59-458DB50CEF5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2C2ACF-10DB-FFEA-6CBA-C27B9CC331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F24EE0-C4BF-FD17-C559-40A1F22A7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6E56B-0234-D14D-B041-EE174572E5FB}" type="datetimeFigureOut">
              <a:rPr lang="en-US" smtClean="0"/>
              <a:t>5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2D3F2D-64EC-780B-FB14-832A79CC4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EB6AC8-7011-C6B0-34D1-6D22CC249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BC2FA-A6A1-4945-AEBF-D322C22E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191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82BDB26-310B-9874-4415-B01E5C009D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E9B345-7D58-F2F2-1BDE-F91039F059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FE158C-1B6A-2165-0446-850B85D84B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36E56B-0234-D14D-B041-EE174572E5FB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60BDE7-07D4-FF81-607D-7A55473704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1C085-3EE9-A7A3-25BF-D146932EBC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EBC2FA-A6A1-4945-AEBF-D322C22E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607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8.png">
            <a:extLst>
              <a:ext uri="{FF2B5EF4-FFF2-40B4-BE49-F238E27FC236}">
                <a16:creationId xmlns:a16="http://schemas.microsoft.com/office/drawing/2014/main" id="{A62B2E49-5DCD-0302-BF51-D3064EFBE0FA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93764" y="272162"/>
            <a:ext cx="6041572" cy="315683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801E832-F100-FE54-EF6C-E083171410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8013" y="3429000"/>
            <a:ext cx="6243513" cy="305457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CBD4DAA-D55B-7BF4-C252-3D27F0B8FE05}"/>
              </a:ext>
            </a:extLst>
          </p:cNvPr>
          <p:cNvSpPr txBox="1"/>
          <p:nvPr/>
        </p:nvSpPr>
        <p:spPr>
          <a:xfrm>
            <a:off x="346202" y="156415"/>
            <a:ext cx="561372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028D318-30A7-3817-0604-EF77CCE42371}"/>
              </a:ext>
            </a:extLst>
          </p:cNvPr>
          <p:cNvSpPr txBox="1"/>
          <p:nvPr/>
        </p:nvSpPr>
        <p:spPr>
          <a:xfrm>
            <a:off x="346202" y="3313253"/>
            <a:ext cx="561372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70EB9C0-EB37-0026-0A30-4965ED3A75F7}"/>
              </a:ext>
            </a:extLst>
          </p:cNvPr>
          <p:cNvSpPr txBox="1"/>
          <p:nvPr/>
        </p:nvSpPr>
        <p:spPr>
          <a:xfrm>
            <a:off x="4518837" y="272162"/>
            <a:ext cx="2294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US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ophelis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U00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11C55E7-E20F-31BA-9265-6AF4ADD5A259}"/>
              </a:ext>
            </a:extLst>
          </p:cNvPr>
          <p:cNvSpPr txBox="1"/>
          <p:nvPr/>
        </p:nvSpPr>
        <p:spPr>
          <a:xfrm>
            <a:off x="3728043" y="3626148"/>
            <a:ext cx="3085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US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igoseptica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C1325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68D848F-1739-D31D-59F6-0E11CA9934B3}"/>
              </a:ext>
            </a:extLst>
          </p:cNvPr>
          <p:cNvSpPr txBox="1"/>
          <p:nvPr/>
        </p:nvSpPr>
        <p:spPr>
          <a:xfrm>
            <a:off x="7283500" y="4609511"/>
            <a:ext cx="43062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ure S1. 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omparision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of the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ss spectrum patterns between MSU001 and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menigoseptica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TCC13253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he primary spectrum for MSU001was compared to the VITEK MS MS-ID database (version 2.0) for identification</a:t>
            </a:r>
            <a:r>
              <a: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1590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45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cheng Chen</dc:creator>
  <cp:lastModifiedBy>Shicheng Chen</cp:lastModifiedBy>
  <cp:revision>6</cp:revision>
  <dcterms:created xsi:type="dcterms:W3CDTF">2023-05-12T02:32:55Z</dcterms:created>
  <dcterms:modified xsi:type="dcterms:W3CDTF">2024-05-16T21:38:11Z</dcterms:modified>
</cp:coreProperties>
</file>